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nu Srivastava" initials="MS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404" y="-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728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771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7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26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784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355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328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120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413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399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155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7CC9A-A315-455B-993F-FAF2FC2C71A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21950-059B-41C1-BC77-BC82EA94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56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961535"/>
              </p:ext>
            </p:extLst>
          </p:nvPr>
        </p:nvGraphicFramePr>
        <p:xfrm>
          <a:off x="990600" y="1401198"/>
          <a:ext cx="7391400" cy="1785756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0668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656202"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                 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</a:t>
                      </a: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Ia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Ib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IIa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58V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IIa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58F)</a:t>
                      </a: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R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3160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005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3119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005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 x 1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cxnSp>
        <p:nvCxnSpPr>
          <p:cNvPr id="4" name="Straight Connector 3"/>
          <p:cNvCxnSpPr/>
          <p:nvPr/>
        </p:nvCxnSpPr>
        <p:spPr>
          <a:xfrm flipH="1" flipV="1">
            <a:off x="990600" y="1401198"/>
            <a:ext cx="1066800" cy="80860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6200" y="107539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.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90600" y="3276600"/>
            <a:ext cx="73914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HO cell lines were engineered to express human Fc receptors. APX005 and APX005M were titrated on cells in an 8-point titration curve 3-fold from 20ug/mL and detected with PE-conjugated secondary antibody. All conditions were tested in triplicate. Binding was determined by flow cytometry and </a:t>
            </a:r>
            <a:r>
              <a:rPr lang="en-US" sz="1400" dirty="0" smtClean="0"/>
              <a:t>affinity (</a:t>
            </a:r>
            <a:r>
              <a:rPr lang="en-US" sz="1400" dirty="0" err="1" smtClean="0"/>
              <a:t>K</a:t>
            </a:r>
            <a:r>
              <a:rPr lang="en-US" sz="1400" baseline="-25000" dirty="0" err="1" smtClean="0"/>
              <a:t>d</a:t>
            </a:r>
            <a:r>
              <a:rPr lang="en-US" sz="1400" dirty="0" smtClean="0"/>
              <a:t>) </a:t>
            </a:r>
            <a:r>
              <a:rPr lang="en-US" sz="1400" dirty="0"/>
              <a:t>was calculated using GraphPad Prism software</a:t>
            </a:r>
            <a:r>
              <a:rPr lang="en-US" sz="1400" dirty="0" smtClean="0"/>
              <a:t>. ND = no binding detect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901728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5106927"/>
              </p:ext>
            </p:extLst>
          </p:nvPr>
        </p:nvGraphicFramePr>
        <p:xfrm>
          <a:off x="4645025" y="3124200"/>
          <a:ext cx="2525713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4" name="Prism 6" r:id="rId3" imgW="3607119" imgH="3840683" progId="Prism6.Document">
                  <p:embed/>
                </p:oleObj>
              </mc:Choice>
              <mc:Fallback>
                <p:oleObj name="Prism 6" r:id="rId3" imgW="3607119" imgH="384068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45025" y="3124200"/>
                        <a:ext cx="2525713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5235436"/>
              </p:ext>
            </p:extLst>
          </p:nvPr>
        </p:nvGraphicFramePr>
        <p:xfrm>
          <a:off x="677863" y="608013"/>
          <a:ext cx="2524125" cy="2682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5" name="Prism 6" r:id="rId5" imgW="3607119" imgH="3831319" progId="Prism6.Document">
                  <p:embed/>
                </p:oleObj>
              </mc:Choice>
              <mc:Fallback>
                <p:oleObj name="Prism 6" r:id="rId5" imgW="3607119" imgH="383131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7863" y="608013"/>
                        <a:ext cx="2524125" cy="2682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2409495"/>
              </p:ext>
            </p:extLst>
          </p:nvPr>
        </p:nvGraphicFramePr>
        <p:xfrm>
          <a:off x="1827213" y="3124200"/>
          <a:ext cx="2522537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6" name="Prism 6" r:id="rId7" imgW="3607119" imgH="3840683" progId="Prism6.Document">
                  <p:embed/>
                </p:oleObj>
              </mc:Choice>
              <mc:Fallback>
                <p:oleObj name="Prism 6" r:id="rId7" imgW="3607119" imgH="384068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27213" y="3124200"/>
                        <a:ext cx="2522537" cy="2689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3722621"/>
              </p:ext>
            </p:extLst>
          </p:nvPr>
        </p:nvGraphicFramePr>
        <p:xfrm>
          <a:off x="3121025" y="604838"/>
          <a:ext cx="2525713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7" name="Prism 6" r:id="rId9" imgW="3607119" imgH="3840683" progId="Prism6.Document">
                  <p:embed/>
                </p:oleObj>
              </mc:Choice>
              <mc:Fallback>
                <p:oleObj name="Prism 6" r:id="rId9" imgW="3607119" imgH="384068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21025" y="604838"/>
                        <a:ext cx="2525713" cy="2689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8035961"/>
              </p:ext>
            </p:extLst>
          </p:nvPr>
        </p:nvGraphicFramePr>
        <p:xfrm>
          <a:off x="5561013" y="608013"/>
          <a:ext cx="3273425" cy="2682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8" name="Prism 6" r:id="rId11" imgW="4677443" imgH="3831319" progId="Prism6.Document">
                  <p:embed/>
                </p:oleObj>
              </mc:Choice>
              <mc:Fallback>
                <p:oleObj name="Prism 6" r:id="rId11" imgW="4677443" imgH="383131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61013" y="608013"/>
                        <a:ext cx="3273425" cy="2682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6200" y="107539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8600" y="5715000"/>
            <a:ext cx="860583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BMC were obtained from freshly isolated human blood (Astarte Biologicals, Bothell, WA) using </a:t>
            </a:r>
            <a:r>
              <a:rPr lang="en-US" sz="1400" dirty="0" err="1"/>
              <a:t>Ficoll</a:t>
            </a:r>
            <a:r>
              <a:rPr lang="en-US" sz="1400" dirty="0"/>
              <a:t> gradient separation. PBMC were plated at 10</a:t>
            </a:r>
            <a:r>
              <a:rPr lang="en-US" sz="1400" baseline="30000" dirty="0"/>
              <a:t>5</a:t>
            </a:r>
            <a:r>
              <a:rPr lang="en-US" sz="1400" dirty="0"/>
              <a:t> cells per well and indicated concentrations of APX005M were added for 48 hours. Supernatants were harvested and analyzed for the indicated cytokines using the MSD platform (</a:t>
            </a:r>
            <a:r>
              <a:rPr lang="en-US" sz="1400" dirty="0" err="1"/>
              <a:t>Meso</a:t>
            </a:r>
            <a:r>
              <a:rPr lang="en-US" sz="1400" dirty="0"/>
              <a:t> Scale Diagnostics, Rockville, MD). </a:t>
            </a:r>
          </a:p>
        </p:txBody>
      </p:sp>
    </p:spTree>
    <p:extLst>
      <p:ext uri="{BB962C8B-B14F-4D97-AF65-F5344CB8AC3E}">
        <p14:creationId xmlns:p14="http://schemas.microsoft.com/office/powerpoint/2010/main" val="568316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37</TotalTime>
  <Words>202</Words>
  <Application>Microsoft Office PowerPoint</Application>
  <PresentationFormat>On-screen Show (4:3)</PresentationFormat>
  <Paragraphs>28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Prism 6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 Filbert</dc:creator>
  <cp:lastModifiedBy>Erin Filbert</cp:lastModifiedBy>
  <cp:revision>17</cp:revision>
  <cp:lastPrinted>2020-07-22T22:08:38Z</cp:lastPrinted>
  <dcterms:created xsi:type="dcterms:W3CDTF">2020-06-15T21:17:53Z</dcterms:created>
  <dcterms:modified xsi:type="dcterms:W3CDTF">2020-08-02T01:27:02Z</dcterms:modified>
</cp:coreProperties>
</file>